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46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49490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4163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135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83470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745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2718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81941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503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618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261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2710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32297-D246-41DA-A72F-4C2902C9A1AD}" type="datetimeFigureOut">
              <a:rPr lang="en-US" smtClean="0"/>
              <a:t>9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D4CCF-BD71-4CA5-8A34-B2E3884C01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3675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60107" y="4313207"/>
            <a:ext cx="8773064" cy="931653"/>
          </a:xfrm>
        </p:spPr>
        <p:txBody>
          <a:bodyPr>
            <a:normAutofit/>
          </a:bodyPr>
          <a:lstStyle/>
          <a:p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Resulting tissue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placement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a 10% increase of (A) tissue stiffness, (B) tissue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olume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the activated layer segment and (C) the combination of both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ffects. For visualization purpose the scaling factor was set to 10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600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4571" y="1138688"/>
            <a:ext cx="9845239" cy="28294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15157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7724" y="827377"/>
            <a:ext cx="8138414" cy="3227038"/>
          </a:xfrm>
        </p:spPr>
      </p:pic>
      <p:sp>
        <p:nvSpPr>
          <p:cNvPr id="5" name="TextBox 4"/>
          <p:cNvSpPr txBox="1"/>
          <p:nvPr/>
        </p:nvSpPr>
        <p:spPr>
          <a:xfrm>
            <a:off x="1781752" y="4408098"/>
            <a:ext cx="849309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Surface plot of the total displacement for the studied region as a function of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seline</a:t>
            </a:r>
          </a:p>
          <a:p>
            <a:pPr algn="just"/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iffness and bulk modulus A) for 2% stiffness change and B) for 10% stiffness </a:t>
            </a:r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nge.</a:t>
            </a: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42494060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552754" y="5114836"/>
            <a:ext cx="924751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A)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placement resulting from changing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ctivated segment of layer one, in tangential direction towards the </a:t>
            </a:r>
            <a:r>
              <a:rPr lang="en-US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yrus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own for the three simulation cases. B)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splacement caused by extending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ctivated segment of layer one from one up to four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gments towards the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yrus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rown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the three simulation cases.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2749" y="1136874"/>
            <a:ext cx="7829943" cy="33919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419012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990100" y="5052388"/>
            <a:ext cx="832449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'Video </a:t>
            </a:r>
            <a:r>
              <a:rPr lang="en-US" b="1">
                <a:latin typeface="Times New Roman" panose="02020603050405020304" pitchFamily="18" charset="0"/>
                <a:cs typeface="Times New Roman" panose="02020603050405020304" pitchFamily="18" charset="0"/>
              </a:rPr>
              <a:t>1.AVI</a:t>
            </a:r>
            <a:r>
              <a:rPr lang="en-US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'.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video showing </a:t>
            </a:r>
            <a:r>
              <a:rPr lang="en-US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yrus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ometry being flattened by prescribed displacement. The color map visualizes the stress distribution.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22774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156</Words>
  <Application>Microsoft Office PowerPoint</Application>
  <PresentationFormat>Widescreen</PresentationFormat>
  <Paragraphs>5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HP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hsa Zoraghi</dc:creator>
  <cp:lastModifiedBy>mahsa Zoraghi</cp:lastModifiedBy>
  <cp:revision>10</cp:revision>
  <dcterms:created xsi:type="dcterms:W3CDTF">2021-06-08T13:34:17Z</dcterms:created>
  <dcterms:modified xsi:type="dcterms:W3CDTF">2021-09-07T19:19:14Z</dcterms:modified>
</cp:coreProperties>
</file>